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E6440C7-10C0-4888-8DEF-0C41372925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17851D3F-F52B-4DBB-ADE9-2156DB30718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6077F65-1397-4AF9-930B-957FD1C23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8F41-B5D9-4C18-952C-5FA23BE2B667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B9CE38C-FF90-42C4-9B08-34BFC7C77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1835A8D4-EE0B-4FB3-9C86-6CC4E8452E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023E-F226-4200-BEB5-62A1C80031A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72030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0EB1B5A-9180-4485-9EC0-B2B62BD177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A3982828-CDC7-4ECE-A091-F6A84A6CF8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733B07F0-724B-42A6-9C18-4AD9A63B10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8F41-B5D9-4C18-952C-5FA23BE2B667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655A9146-3C78-463E-AE34-CEECF8B20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B180480D-C6B6-4007-B369-46BE05627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023E-F226-4200-BEB5-62A1C80031A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05385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B09C3CC0-B112-4B49-A4E9-47C413156E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3E600640-E530-40AF-8204-B91AF14309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AF009521-AAB4-487E-B962-2ED535A2B8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8F41-B5D9-4C18-952C-5FA23BE2B667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AAECFD1F-7BCF-41CE-A388-975599521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5315F5EC-09F4-4390-95A9-79FB37C710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023E-F226-4200-BEB5-62A1C80031A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555416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D6BE456-864E-46A6-8B94-E5F3851BE3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74D0E6BF-8E7B-40F9-842E-00B01611C4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93C4208-FDA8-489A-998A-BE2D975F1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8F41-B5D9-4C18-952C-5FA23BE2B667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6A50B1BF-6992-4C41-825D-D2EAA9DD31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69DA14F5-30B5-40F6-896C-698CD3E05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023E-F226-4200-BEB5-62A1C80031A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73172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2BDEFA3-C162-4ACA-8491-5ED1BB2F19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3317C5AD-B395-4D2F-A48A-C51F81F695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C9FED787-15E0-496F-BC36-47D21F5354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8F41-B5D9-4C18-952C-5FA23BE2B667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7C77E82F-E9F9-4ACD-98F0-DCEE4C049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372795E1-EB91-4990-9541-70C2C8D51D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023E-F226-4200-BEB5-62A1C80031A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61690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6F4F9D1-0156-4020-9643-450A6F720C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63D10971-0BFF-44C3-96A4-61FF8762DC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3F06D58E-30BD-4437-95C7-F8F165D904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E76E124A-EC44-45D1-9875-24C63F42ED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8F41-B5D9-4C18-952C-5FA23BE2B667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68E0F6C1-90EC-4A4D-BCEA-C5F5B280B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B76102FF-DC51-4186-A620-7184A753BF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023E-F226-4200-BEB5-62A1C80031A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58269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48A6B96A-B9F8-41BD-AB05-91B6A8E7F3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9BAEE48B-C609-4235-8287-A8C3282AA3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E4A1EC7B-DF0B-4BC8-9914-5EEFF6D328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C2786EF1-4ABF-4D3A-9225-2FDAE2B42EF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64FAD494-E2D5-4002-B9C3-3B2FB61DBF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AFA78037-0E10-4254-9B90-FE567E656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8F41-B5D9-4C18-952C-5FA23BE2B667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418D394A-BD37-41EC-8974-9E84EC655C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64F4453B-BAFD-4411-A349-85015B759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023E-F226-4200-BEB5-62A1C80031A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15817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B126371-2AD2-4DAB-9E11-CF63328D1D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74FCA4CB-FD28-4D74-A606-3B93F34521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8F41-B5D9-4C18-952C-5FA23BE2B667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9FFBBC96-D580-49A9-8CB3-25F5DC2BB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AED6EB7B-6FEF-4CF7-B50E-D5743AEF9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023E-F226-4200-BEB5-62A1C80031A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662748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2446BB77-66A9-4B94-8876-CF49857DC1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8F41-B5D9-4C18-952C-5FA23BE2B667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75916F27-9CA1-4833-B10D-584BE0C406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424EB5F4-EF78-42FD-939C-5B5034DAD1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023E-F226-4200-BEB5-62A1C80031A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81793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AA27B90F-EFD8-4AE1-B5DC-03D5FD84A4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F0651543-036D-4C7E-BF5F-2CDC5606DA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DD4F4DEE-2245-437D-9BBF-89BEFC1524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7F4D08DB-3719-4902-852F-E3C6A15061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8F41-B5D9-4C18-952C-5FA23BE2B667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F59C2DA9-187A-4996-A2E8-C5DB314E5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5F3038FA-E70A-4FF2-8B35-4848478D29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023E-F226-4200-BEB5-62A1C80031A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41163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7796476-1118-422C-B2B7-B5BBF62682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A13D0749-7A3E-40F5-8790-B03BDCAC9A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B807D79A-CD67-4FF9-A310-0CE96B657D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97635024-0A80-4AB3-B13E-038186A62C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98F41-B5D9-4C18-952C-5FA23BE2B667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49B8CBF6-7287-480F-AF4C-1F06D3FBF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2047B9D7-A094-4971-969F-8ACF939E0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9B023E-F226-4200-BEB5-62A1C80031A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90795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5F9E7B58-7A18-41E0-9B84-11554C2A62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270DE8C4-178F-4756-8D20-EEB34D58A9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2EE6D89-CD37-4163-80F1-65E7512E11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C98F41-B5D9-4C18-952C-5FA23BE2B667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49D0B96-4E5C-46A0-87E0-ACB240924D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9A252FF-9DA3-4C8C-84FD-16C21337C0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9B023E-F226-4200-BEB5-62A1C80031A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66420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ktangel 3">
            <a:extLst>
              <a:ext uri="{FF2B5EF4-FFF2-40B4-BE49-F238E27FC236}">
                <a16:creationId xmlns:a16="http://schemas.microsoft.com/office/drawing/2014/main" id="{EFC3D3DB-5351-4042-804D-8AA0A8A6CC0F}"/>
              </a:ext>
            </a:extLst>
          </p:cNvPr>
          <p:cNvSpPr/>
          <p:nvPr/>
        </p:nvSpPr>
        <p:spPr>
          <a:xfrm>
            <a:off x="3048000" y="2136339"/>
            <a:ext cx="6096000" cy="2585323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Twitter summary</a:t>
            </a:r>
            <a:endParaRPr lang="sv-SE" dirty="0"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AU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During complete coronary balloon occlusion, coronary collaterals provided more than half of normal myocardial perfusion in patients with coronary artery disease.</a:t>
            </a:r>
            <a:endParaRPr lang="sv-SE" dirty="0"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@</a:t>
            </a:r>
            <a:r>
              <a:rPr lang="en-US" dirty="0" err="1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UAllahwala</a:t>
            </a:r>
            <a:r>
              <a:rPr lang="en-US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; @</a:t>
            </a:r>
            <a:r>
              <a:rPr lang="en-US" dirty="0" err="1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mugander</a:t>
            </a:r>
            <a:r>
              <a:rPr lang="en-US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; @</a:t>
            </a:r>
            <a:r>
              <a:rPr lang="en-US" dirty="0" err="1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thomas_lindow</a:t>
            </a:r>
            <a:r>
              <a:rPr lang="en-US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; @</a:t>
            </a:r>
            <a:r>
              <a:rPr lang="en-US" dirty="0" err="1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ydney_Uni</a:t>
            </a:r>
            <a:endParaRPr lang="sv-SE" dirty="0"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5374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Bredbild</PresentationFormat>
  <Paragraphs>3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5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ahoma</vt:lpstr>
      <vt:lpstr>Times New Roman</vt:lpstr>
      <vt:lpstr>Office-tema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Åkesson Lindow Thomas SHV klin fys Växjö</dc:creator>
  <cp:lastModifiedBy>Åkesson Lindow Thomas SHV klin fys Växjö</cp:lastModifiedBy>
  <cp:revision>1</cp:revision>
  <dcterms:created xsi:type="dcterms:W3CDTF">2023-03-17T08:26:29Z</dcterms:created>
  <dcterms:modified xsi:type="dcterms:W3CDTF">2023-03-17T08:27:14Z</dcterms:modified>
</cp:coreProperties>
</file>